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379E6E-4432-42F2-BE11-FCFD992B0F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BDFCA26-42F3-4FC7-9E67-0AD0FD9CE9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AF4AFD-2ADD-4A1A-88AC-E1F9B5147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6F9318-1EF1-4710-92F0-73531C046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4399EC-5418-41F1-A60B-CD4632E8B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191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4238CF-5D30-4813-B664-C2E5741F74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4B642DB-8562-4810-A052-C0B4392899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C90B68-5874-403D-8EC6-82DDB0F3B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57CD23-BEBD-4356-A920-6E8C2C5FA5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5B53F5-1479-45AC-93E7-0E7CF8294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0349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4F69F0C-6163-40FE-852F-DC614D0CC7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FB898F2-2DD6-4358-865C-4D42BAB0CF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986CF0-4CE4-426B-ACCF-21A1B2C95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ACA1A0-CD76-4A48-BD1E-01346B37F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C2DE1D9-0E25-4799-9800-44658D4C2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0533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A2CE44-ED4E-4C85-84A6-918E0CAA7E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B1AB79-CF36-4E85-AAAB-22EB7AE9C1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F41287-4CD6-4B47-9F6E-D9B4148F5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9E94AB-65FB-4CCA-A2C5-A333236FFE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DE6CA3-CAA7-4C55-B904-116B9C746E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7201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A8D576-6BFF-4F75-8147-EA64637DDB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2AAC8FC-5473-4B4B-85D6-43A4526AA3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C6E1BF-54BD-484B-90FF-E026B706A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B766A3-E935-4EB4-896F-CD7D4DB26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004337-6C91-497F-97FD-C4162525B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875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461EF6-B003-4EE6-8F10-204723773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2C249B-D432-45D6-81A2-AE932D0908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8FA9F2D-0B1B-4EAB-A602-BF7B6A7C48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3F7589-6040-42E8-8562-D8320A8D1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248F19B-689F-4290-B47A-A5CDAC4F7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9E69CB-6876-4792-BA45-6AB0C739D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7780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616ABD4-189F-43CB-869B-8822EE16E6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4E67894-D341-4AF8-BF56-BC4F8F4058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BD6A8A-2EEE-4B2C-B14E-06F0A908DA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BD076D0-8562-4363-B158-2FA9CBB95B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9146C70-6825-4A54-BD81-AFB328F5CA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A7C3EEF-8F3E-42FF-884F-4C0DC8DA7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5CD11E1-B44A-4A80-B5C5-8095A04F7A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59FE91D-20D6-460B-916F-98CCCDE12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4388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D6E135-7867-4921-9182-0055A28448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92AB27C-08C3-45A7-A813-FDFA4EDA9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34FE262-A00F-4423-8D84-E60C6B9E7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E4716E6-DCD7-408F-A09B-2B7E87D23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24622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ACDDA4A-3DEA-498F-A290-003E6BD3D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7A11829-36FE-4217-998F-F4C1EACF4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DC59ED0-DA91-4BC8-B09E-6F84E6F73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3146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A88C56-453C-4180-AA3B-0A878D8661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167305-07EA-40BB-96AA-928F39118A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765CC9-2CC9-40AA-A138-3ED225D721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37B0F5-2415-4B50-AE48-25E5ABBA6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EFE253-21B8-4DDF-AA23-854F038E5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4B7860-6D41-4B78-95E1-5654AF178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1669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DD52F8-748D-4C16-BBE9-ACACDCBE49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3C74060-41B0-4DC1-8D04-18A3798FD5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4F3F18-F1F7-40E3-A8D0-82A853E023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4236B6F-B461-4062-AE44-3A88811ED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533F58D-3042-49B2-9DFA-74FD30B39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E04FAC0-FE28-4691-8BA1-75ADBBF27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7489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4E1E55A-E4EF-41F0-AD33-060948B81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85B91B-BCFB-4B39-B4E3-A99B9546EE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E7B146-5D87-43C6-89C1-9843CE796E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2C41B-3C0A-4A80-85D7-B9B52EDE5360}" type="datetimeFigureOut">
              <a:rPr lang="zh-CN" altLang="en-US" smtClean="0"/>
              <a:t>2022/6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12154B-C470-4402-A5DE-F041F27032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88C37F-FE01-4FCF-9978-1FB110A5C6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D4E0A9-8615-43EE-A2C6-684CE229A5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12460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06B0827D-9E60-4F1C-B24B-2AC626C319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34600" y="380139"/>
            <a:ext cx="1659028" cy="170164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7FB4074-8F32-4247-B407-614561A2E2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2470" y="549842"/>
            <a:ext cx="2159258" cy="169866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4F18AA20-8EA4-47D4-8BFF-B1F04C4D94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31100" y="581723"/>
            <a:ext cx="2138883" cy="1670120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2B9C7E1A-5091-4F82-B87D-149E445F5DE6}"/>
              </a:ext>
            </a:extLst>
          </p:cNvPr>
          <p:cNvSpPr txBox="1"/>
          <p:nvPr/>
        </p:nvSpPr>
        <p:spPr>
          <a:xfrm rot="16200000">
            <a:off x="3618961" y="1102840"/>
            <a:ext cx="1763215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probability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">
            <a:extLst>
              <a:ext uri="{FF2B5EF4-FFF2-40B4-BE49-F238E27FC236}">
                <a16:creationId xmlns:a16="http://schemas.microsoft.com/office/drawing/2014/main" id="{5EB18ABC-51AA-4CC1-8A33-310CCF8A00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5469" y="2373021"/>
            <a:ext cx="10440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Times New Roman" panose="02020603050405020304" pitchFamily="18" charset="0"/>
                <a:cs typeface="Times New Roman" pitchFamily="18" charset="0"/>
              </a:rPr>
              <a:t>Time (</a:t>
            </a: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year)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A9F2B56-9DA6-4A73-9F48-273FDE44C403}"/>
              </a:ext>
            </a:extLst>
          </p:cNvPr>
          <p:cNvSpPr txBox="1"/>
          <p:nvPr/>
        </p:nvSpPr>
        <p:spPr>
          <a:xfrm rot="16200000">
            <a:off x="650151" y="1048595"/>
            <a:ext cx="1763215" cy="307777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probability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">
            <a:extLst>
              <a:ext uri="{FF2B5EF4-FFF2-40B4-BE49-F238E27FC236}">
                <a16:creationId xmlns:a16="http://schemas.microsoft.com/office/drawing/2014/main" id="{26162120-37EA-4B76-81E3-CAD8AAB5C7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74157" y="2373021"/>
            <a:ext cx="104400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 smtClean="0">
                <a:latin typeface="Times New Roman" panose="02020603050405020304" pitchFamily="18" charset="0"/>
                <a:cs typeface="Times New Roman" pitchFamily="18" charset="0"/>
              </a:rPr>
              <a:t>Time (</a:t>
            </a: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year)</a:t>
            </a:r>
          </a:p>
        </p:txBody>
      </p:sp>
      <p:sp>
        <p:nvSpPr>
          <p:cNvPr id="29" name="TextBox 78">
            <a:extLst>
              <a:ext uri="{FF2B5EF4-FFF2-40B4-BE49-F238E27FC236}">
                <a16:creationId xmlns:a16="http://schemas.microsoft.com/office/drawing/2014/main" id="{B7839504-E742-40E3-A491-B74D0E7D31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7027" y="18113"/>
            <a:ext cx="734678" cy="2317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.0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75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50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25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00</a:t>
            </a:r>
          </a:p>
        </p:txBody>
      </p:sp>
      <p:sp>
        <p:nvSpPr>
          <p:cNvPr id="30" name="TextBox 78">
            <a:extLst>
              <a:ext uri="{FF2B5EF4-FFF2-40B4-BE49-F238E27FC236}">
                <a16:creationId xmlns:a16="http://schemas.microsoft.com/office/drawing/2014/main" id="{EE463321-4682-4F12-8440-26E7648AF7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38439" y="14373"/>
            <a:ext cx="734678" cy="2317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.0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75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50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25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00</a:t>
            </a:r>
          </a:p>
        </p:txBody>
      </p:sp>
      <p:sp>
        <p:nvSpPr>
          <p:cNvPr id="31" name="TextBox 2">
            <a:extLst>
              <a:ext uri="{FF2B5EF4-FFF2-40B4-BE49-F238E27FC236}">
                <a16:creationId xmlns:a16="http://schemas.microsoft.com/office/drawing/2014/main" id="{9FEFEA45-700E-4D97-8CF8-DCC54B4974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2284" y="2144403"/>
            <a:ext cx="292744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0     2    4    6    8    10   12   14         </a:t>
            </a:r>
          </a:p>
        </p:txBody>
      </p:sp>
      <p:sp>
        <p:nvSpPr>
          <p:cNvPr id="32" name="TextBox 2">
            <a:extLst>
              <a:ext uri="{FF2B5EF4-FFF2-40B4-BE49-F238E27FC236}">
                <a16:creationId xmlns:a16="http://schemas.microsoft.com/office/drawing/2014/main" id="{37A8B44D-97B6-46FC-9A60-D706CCFFA5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4499" y="2178792"/>
            <a:ext cx="292744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0       4        8      12      16         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54E1EC8D-6C06-44E2-9772-68C0BD553E34}"/>
              </a:ext>
            </a:extLst>
          </p:cNvPr>
          <p:cNvSpPr txBox="1"/>
          <p:nvPr/>
        </p:nvSpPr>
        <p:spPr>
          <a:xfrm>
            <a:off x="5554693" y="315092"/>
            <a:ext cx="151861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AD (CDKN1B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EAB1E93-F636-4A7E-BB11-5B4E5124B710}"/>
              </a:ext>
            </a:extLst>
          </p:cNvPr>
          <p:cNvSpPr txBox="1"/>
          <p:nvPr/>
        </p:nvSpPr>
        <p:spPr>
          <a:xfrm>
            <a:off x="2541370" y="272002"/>
            <a:ext cx="151861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SC(CDKN1B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2">
            <a:extLst>
              <a:ext uri="{FF2B5EF4-FFF2-40B4-BE49-F238E27FC236}">
                <a16:creationId xmlns:a16="http://schemas.microsoft.com/office/drawing/2014/main" id="{A1A218BE-108E-4F26-A41A-ECC46AD99F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9267" y="1292141"/>
            <a:ext cx="154740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i="1" dirty="0">
                <a:latin typeface="Times New Roman" panose="02020603050405020304" pitchFamily="18" charset="0"/>
                <a:cs typeface="Times New Roman" pitchFamily="18" charset="0"/>
              </a:rPr>
              <a:t>P</a:t>
            </a: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=0.200</a:t>
            </a:r>
          </a:p>
        </p:txBody>
      </p:sp>
      <p:sp>
        <p:nvSpPr>
          <p:cNvPr id="37" name="TextBox 2">
            <a:extLst>
              <a:ext uri="{FF2B5EF4-FFF2-40B4-BE49-F238E27FC236}">
                <a16:creationId xmlns:a16="http://schemas.microsoft.com/office/drawing/2014/main" id="{B6A14CC2-66A9-4BD2-91E4-601E7C0650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5557" y="1283036"/>
            <a:ext cx="154740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i="1" dirty="0">
                <a:latin typeface="Times New Roman" panose="02020603050405020304" pitchFamily="18" charset="0"/>
                <a:cs typeface="Times New Roman" pitchFamily="18" charset="0"/>
              </a:rPr>
              <a:t>P</a:t>
            </a: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=0.017</a:t>
            </a: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1C11C876-C6EF-4D0A-AC15-0A9AD7387194}"/>
              </a:ext>
            </a:extLst>
          </p:cNvPr>
          <p:cNvCxnSpPr/>
          <p:nvPr/>
        </p:nvCxnSpPr>
        <p:spPr>
          <a:xfrm>
            <a:off x="2350105" y="843684"/>
            <a:ext cx="156754" cy="0"/>
          </a:xfrm>
          <a:prstGeom prst="line">
            <a:avLst/>
          </a:prstGeom>
          <a:ln w="1905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29CD4B32-C31E-4DDA-A13E-F726338134D2}"/>
              </a:ext>
            </a:extLst>
          </p:cNvPr>
          <p:cNvCxnSpPr/>
          <p:nvPr/>
        </p:nvCxnSpPr>
        <p:spPr>
          <a:xfrm>
            <a:off x="2350105" y="688050"/>
            <a:ext cx="156754" cy="0"/>
          </a:xfrm>
          <a:prstGeom prst="line">
            <a:avLst/>
          </a:prstGeom>
          <a:ln w="19050">
            <a:solidFill>
              <a:srgbClr val="FF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9A4BCDD5-98C6-4C8E-A9CA-B093CEF61EA4}"/>
              </a:ext>
            </a:extLst>
          </p:cNvPr>
          <p:cNvSpPr txBox="1"/>
          <p:nvPr/>
        </p:nvSpPr>
        <p:spPr>
          <a:xfrm>
            <a:off x="2442136" y="540963"/>
            <a:ext cx="17442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mRNA level(n=370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8166FB4-2628-4296-97C4-5D4EB7FA35CF}"/>
              </a:ext>
            </a:extLst>
          </p:cNvPr>
          <p:cNvSpPr txBox="1"/>
          <p:nvPr/>
        </p:nvSpPr>
        <p:spPr>
          <a:xfrm>
            <a:off x="2449702" y="707883"/>
            <a:ext cx="18516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mRNA level(n=124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467F4DC2-AC54-4017-A506-8251A0BB0924}"/>
              </a:ext>
            </a:extLst>
          </p:cNvPr>
          <p:cNvCxnSpPr/>
          <p:nvPr/>
        </p:nvCxnSpPr>
        <p:spPr>
          <a:xfrm>
            <a:off x="5391101" y="872442"/>
            <a:ext cx="156754" cy="0"/>
          </a:xfrm>
          <a:prstGeom prst="line">
            <a:avLst/>
          </a:prstGeom>
          <a:ln w="1905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2DD39790-C468-4ADD-9EFA-2BDD598ACE81}"/>
              </a:ext>
            </a:extLst>
          </p:cNvPr>
          <p:cNvCxnSpPr/>
          <p:nvPr/>
        </p:nvCxnSpPr>
        <p:spPr>
          <a:xfrm>
            <a:off x="5391101" y="716808"/>
            <a:ext cx="156754" cy="0"/>
          </a:xfrm>
          <a:prstGeom prst="line">
            <a:avLst/>
          </a:prstGeom>
          <a:ln w="19050">
            <a:solidFill>
              <a:srgbClr val="FF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9B0E7EA1-0C91-45FF-AB41-86029F7ED82F}"/>
              </a:ext>
            </a:extLst>
          </p:cNvPr>
          <p:cNvSpPr txBox="1"/>
          <p:nvPr/>
        </p:nvSpPr>
        <p:spPr>
          <a:xfrm>
            <a:off x="5459068" y="569721"/>
            <a:ext cx="18767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 mRNA level(n=267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44F3A85-F35F-4960-8309-8E0C39C62075}"/>
              </a:ext>
            </a:extLst>
          </p:cNvPr>
          <p:cNvSpPr txBox="1"/>
          <p:nvPr/>
        </p:nvSpPr>
        <p:spPr>
          <a:xfrm>
            <a:off x="5466635" y="736641"/>
            <a:ext cx="21366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 mRNA level(n=233)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7AA813A-70A0-46D6-9800-168B95DC7B2B}"/>
              </a:ext>
            </a:extLst>
          </p:cNvPr>
          <p:cNvSpPr txBox="1"/>
          <p:nvPr/>
        </p:nvSpPr>
        <p:spPr>
          <a:xfrm>
            <a:off x="1025676" y="272002"/>
            <a:ext cx="3077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0BAB9D13-2CEB-49FF-9372-59418FCE3A1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7345" y="3538474"/>
            <a:ext cx="3970500" cy="1562783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E7CFD45B-7D47-4E6C-AB34-1866B59CEA77}"/>
              </a:ext>
            </a:extLst>
          </p:cNvPr>
          <p:cNvSpPr txBox="1"/>
          <p:nvPr/>
        </p:nvSpPr>
        <p:spPr>
          <a:xfrm>
            <a:off x="3880087" y="300659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7295456C-E913-4F6A-BB2A-16BC9759DD9C}"/>
              </a:ext>
            </a:extLst>
          </p:cNvPr>
          <p:cNvSpPr txBox="1"/>
          <p:nvPr/>
        </p:nvSpPr>
        <p:spPr>
          <a:xfrm rot="16200000">
            <a:off x="3664649" y="4318710"/>
            <a:ext cx="76908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AD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675652A6-8086-4EB4-B745-417875A599D2}"/>
              </a:ext>
            </a:extLst>
          </p:cNvPr>
          <p:cNvSpPr txBox="1"/>
          <p:nvPr/>
        </p:nvSpPr>
        <p:spPr>
          <a:xfrm rot="16200000">
            <a:off x="3289887" y="3259686"/>
            <a:ext cx="151861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SC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9124E39-E4E1-4F7B-8B3C-615A4A29EDAC}"/>
              </a:ext>
            </a:extLst>
          </p:cNvPr>
          <p:cNvSpPr txBox="1"/>
          <p:nvPr/>
        </p:nvSpPr>
        <p:spPr>
          <a:xfrm>
            <a:off x="4403197" y="3304305"/>
            <a:ext cx="30549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histochemical analysis of p27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2">
            <a:extLst>
              <a:ext uri="{FF2B5EF4-FFF2-40B4-BE49-F238E27FC236}">
                <a16:creationId xmlns:a16="http://schemas.microsoft.com/office/drawing/2014/main" id="{65930B06-8DF2-401B-AB4E-B7F0832EC7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57648" y="4895083"/>
            <a:ext cx="154740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T1    T2    T3    T4    </a:t>
            </a:r>
          </a:p>
        </p:txBody>
      </p:sp>
      <p:sp>
        <p:nvSpPr>
          <p:cNvPr id="55" name="TextBox 78">
            <a:extLst>
              <a:ext uri="{FF2B5EF4-FFF2-40B4-BE49-F238E27FC236}">
                <a16:creationId xmlns:a16="http://schemas.microsoft.com/office/drawing/2014/main" id="{B4DA65D1-C7C8-4A04-BFE6-57060D6D6D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70599" y="2923931"/>
            <a:ext cx="467485" cy="21689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8.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6.0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4.0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2.0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0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6BC552FD-A893-408F-B57A-94FFC9DBD126}"/>
              </a:ext>
            </a:extLst>
          </p:cNvPr>
          <p:cNvSpPr txBox="1"/>
          <p:nvPr/>
        </p:nvSpPr>
        <p:spPr>
          <a:xfrm rot="16200000">
            <a:off x="7718875" y="3714064"/>
            <a:ext cx="1670118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494(n=475)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7" name="图片 56">
            <a:extLst>
              <a:ext uri="{FF2B5EF4-FFF2-40B4-BE49-F238E27FC236}">
                <a16:creationId xmlns:a16="http://schemas.microsoft.com/office/drawing/2014/main" id="{81C88996-1459-48AD-A80C-2FF7ED9CB9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46354" y="3254377"/>
            <a:ext cx="1647274" cy="1701646"/>
          </a:xfrm>
          <a:prstGeom prst="rect">
            <a:avLst/>
          </a:prstGeom>
        </p:spPr>
      </p:pic>
      <p:sp>
        <p:nvSpPr>
          <p:cNvPr id="58" name="TextBox 174">
            <a:extLst>
              <a:ext uri="{FF2B5EF4-FFF2-40B4-BE49-F238E27FC236}">
                <a16:creationId xmlns:a16="http://schemas.microsoft.com/office/drawing/2014/main" id="{CA52880F-F625-45DF-838C-63C3318A31D6}"/>
              </a:ext>
            </a:extLst>
          </p:cNvPr>
          <p:cNvSpPr txBox="1"/>
          <p:nvPr/>
        </p:nvSpPr>
        <p:spPr>
          <a:xfrm>
            <a:off x="9435199" y="3254377"/>
            <a:ext cx="332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59" name="TextBox 174">
            <a:extLst>
              <a:ext uri="{FF2B5EF4-FFF2-40B4-BE49-F238E27FC236}">
                <a16:creationId xmlns:a16="http://schemas.microsoft.com/office/drawing/2014/main" id="{2EF7CD83-889B-4F94-AC99-AE4F0FF0A6EB}"/>
              </a:ext>
            </a:extLst>
          </p:cNvPr>
          <p:cNvSpPr txBox="1"/>
          <p:nvPr/>
        </p:nvSpPr>
        <p:spPr>
          <a:xfrm>
            <a:off x="9277595" y="3416896"/>
            <a:ext cx="332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0D08B761-43F5-466D-A705-E29799731250}"/>
              </a:ext>
            </a:extLst>
          </p:cNvPr>
          <p:cNvSpPr txBox="1"/>
          <p:nvPr/>
        </p:nvSpPr>
        <p:spPr>
          <a:xfrm>
            <a:off x="1017271" y="273748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F09A27F-8EBA-4DEA-956C-E65D394117B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85850" y="2907510"/>
            <a:ext cx="1412337" cy="2119756"/>
          </a:xfrm>
          <a:prstGeom prst="rect">
            <a:avLst/>
          </a:prstGeom>
        </p:spPr>
      </p:pic>
      <p:sp>
        <p:nvSpPr>
          <p:cNvPr id="62" name="TextBox 2">
            <a:extLst>
              <a:ext uri="{FF2B5EF4-FFF2-40B4-BE49-F238E27FC236}">
                <a16:creationId xmlns:a16="http://schemas.microsoft.com/office/drawing/2014/main" id="{C000D49B-4A43-4884-86D7-664C468AD998}"/>
              </a:ext>
            </a:extLst>
          </p:cNvPr>
          <p:cNvSpPr txBox="1">
            <a:spLocks noChangeArrowheads="1"/>
          </p:cNvSpPr>
          <p:nvPr/>
        </p:nvSpPr>
        <p:spPr bwMode="auto">
          <a:xfrm rot="19340808">
            <a:off x="1499365" y="5224621"/>
            <a:ext cx="1250948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LUSC(n=325)</a:t>
            </a:r>
          </a:p>
        </p:txBody>
      </p:sp>
      <p:sp>
        <p:nvSpPr>
          <p:cNvPr id="63" name="TextBox 2">
            <a:extLst>
              <a:ext uri="{FF2B5EF4-FFF2-40B4-BE49-F238E27FC236}">
                <a16:creationId xmlns:a16="http://schemas.microsoft.com/office/drawing/2014/main" id="{5BC27EC7-3756-4E4E-97A4-6EB5423E085D}"/>
              </a:ext>
            </a:extLst>
          </p:cNvPr>
          <p:cNvSpPr txBox="1">
            <a:spLocks noChangeArrowheads="1"/>
          </p:cNvSpPr>
          <p:nvPr/>
        </p:nvSpPr>
        <p:spPr bwMode="auto">
          <a:xfrm rot="19340808">
            <a:off x="2089894" y="5255030"/>
            <a:ext cx="1250948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LUAD(n=362)</a:t>
            </a:r>
          </a:p>
        </p:txBody>
      </p:sp>
      <p:sp>
        <p:nvSpPr>
          <p:cNvPr id="64" name="TextBox 78">
            <a:extLst>
              <a:ext uri="{FF2B5EF4-FFF2-40B4-BE49-F238E27FC236}">
                <a16:creationId xmlns:a16="http://schemas.microsoft.com/office/drawing/2014/main" id="{78C10A68-1F82-4D75-8B7A-7F9961F73B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07591" y="2383274"/>
            <a:ext cx="734678" cy="2748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2.0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1.0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0.0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-1.00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9C5E5206-B9FF-4CD1-9A08-00ADAC2FA190}"/>
              </a:ext>
            </a:extLst>
          </p:cNvPr>
          <p:cNvSpPr txBox="1"/>
          <p:nvPr/>
        </p:nvSpPr>
        <p:spPr>
          <a:xfrm rot="16200000">
            <a:off x="561994" y="3661236"/>
            <a:ext cx="19070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27 protein abundanc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174">
            <a:extLst>
              <a:ext uri="{FF2B5EF4-FFF2-40B4-BE49-F238E27FC236}">
                <a16:creationId xmlns:a16="http://schemas.microsoft.com/office/drawing/2014/main" id="{EDB7F1F3-4F4E-423A-A7C0-E803DE03E44C}"/>
              </a:ext>
            </a:extLst>
          </p:cNvPr>
          <p:cNvSpPr txBox="1"/>
          <p:nvPr/>
        </p:nvSpPr>
        <p:spPr>
          <a:xfrm>
            <a:off x="2461982" y="3023115"/>
            <a:ext cx="7192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891E7DE-7253-4E0E-8799-782E1B81B62E}"/>
              </a:ext>
            </a:extLst>
          </p:cNvPr>
          <p:cNvSpPr txBox="1"/>
          <p:nvPr/>
        </p:nvSpPr>
        <p:spPr>
          <a:xfrm>
            <a:off x="606893" y="5882437"/>
            <a:ext cx="10978213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 S1. The level of p27 or miRNA-494 based on the open database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A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rvival curves of LUSC or LUAD patients with high or low CDKN1B mRNA level (HPA database).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-C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27 protein level (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TCGA database) and immunohistochemical analysis(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HPA database) in patients diagnosed with LUSC or LUAD. 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D-E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iR-494 level in the healthy </a:t>
            </a:r>
            <a:r>
              <a:rPr lang="en-US" altLang="zh-CN" sz="14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s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USC patient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D)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nd LUSC with different T categories</a:t>
            </a: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E)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5, 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000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7730E301-C5EC-483C-A09B-2A7D166920EA}"/>
              </a:ext>
            </a:extLst>
          </p:cNvPr>
          <p:cNvSpPr txBox="1"/>
          <p:nvPr/>
        </p:nvSpPr>
        <p:spPr>
          <a:xfrm>
            <a:off x="8020509" y="31922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78">
            <a:extLst>
              <a:ext uri="{FF2B5EF4-FFF2-40B4-BE49-F238E27FC236}">
                <a16:creationId xmlns:a16="http://schemas.microsoft.com/office/drawing/2014/main" id="{9A2E05B9-44B3-4133-B53E-746D61281C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558800" y="27324"/>
            <a:ext cx="467485" cy="2358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8.0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6.0</a:t>
            </a: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4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4.0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2.0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itchFamily="18" charset="0"/>
                <a:cs typeface="Times New Roman" pitchFamily="18" charset="0"/>
              </a:rPr>
              <a:t>0.0</a:t>
            </a: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  <a:p>
            <a:pPr algn="ctr" eaLnBrk="1" hangingPunct="1">
              <a:lnSpc>
                <a:spcPts val="300"/>
              </a:lnSpc>
              <a:spcBef>
                <a:spcPct val="0"/>
              </a:spcBef>
              <a:buFontTx/>
              <a:buNone/>
            </a:pPr>
            <a:endParaRPr lang="en-US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8F9919DF-5BF7-472C-913B-274F49EB81AF}"/>
              </a:ext>
            </a:extLst>
          </p:cNvPr>
          <p:cNvSpPr txBox="1"/>
          <p:nvPr/>
        </p:nvSpPr>
        <p:spPr>
          <a:xfrm rot="16200000">
            <a:off x="8105842" y="1010302"/>
            <a:ext cx="81480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R-494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2">
            <a:extLst>
              <a:ext uri="{FF2B5EF4-FFF2-40B4-BE49-F238E27FC236}">
                <a16:creationId xmlns:a16="http://schemas.microsoft.com/office/drawing/2014/main" id="{71F46959-3957-41F1-BAD8-FFE775F241CA}"/>
              </a:ext>
            </a:extLst>
          </p:cNvPr>
          <p:cNvSpPr txBox="1">
            <a:spLocks noChangeArrowheads="1"/>
          </p:cNvSpPr>
          <p:nvPr/>
        </p:nvSpPr>
        <p:spPr bwMode="auto">
          <a:xfrm rot="19377830">
            <a:off x="8375640" y="2054925"/>
            <a:ext cx="1953961" cy="30777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Normal(n=45)</a:t>
            </a: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B6BD895A-688D-49C0-96B2-655BA79D1C51}"/>
              </a:ext>
            </a:extLst>
          </p:cNvPr>
          <p:cNvSpPr txBox="1"/>
          <p:nvPr/>
        </p:nvSpPr>
        <p:spPr>
          <a:xfrm rot="19210888">
            <a:off x="9111410" y="2280734"/>
            <a:ext cx="136715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400" dirty="0">
                <a:latin typeface="Times New Roman" panose="02020603050405020304" pitchFamily="18" charset="0"/>
                <a:cs typeface="Times New Roman" pitchFamily="18" charset="0"/>
              </a:rPr>
              <a:t>LUSC(n=478)</a:t>
            </a:r>
            <a:endParaRPr lang="zh-CN" altLang="en-US" sz="1400" dirty="0"/>
          </a:p>
        </p:txBody>
      </p:sp>
      <p:sp>
        <p:nvSpPr>
          <p:cNvPr id="73" name="TextBox 174">
            <a:extLst>
              <a:ext uri="{FF2B5EF4-FFF2-40B4-BE49-F238E27FC236}">
                <a16:creationId xmlns:a16="http://schemas.microsoft.com/office/drawing/2014/main" id="{E57ADBB9-B50E-4855-A532-4B1F30E0B466}"/>
              </a:ext>
            </a:extLst>
          </p:cNvPr>
          <p:cNvSpPr txBox="1"/>
          <p:nvPr/>
        </p:nvSpPr>
        <p:spPr>
          <a:xfrm>
            <a:off x="9415414" y="433761"/>
            <a:ext cx="6610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77CA2E49-B456-4549-905C-889106C5EA0A}"/>
              </a:ext>
            </a:extLst>
          </p:cNvPr>
          <p:cNvCxnSpPr>
            <a:cxnSpLocks/>
          </p:cNvCxnSpPr>
          <p:nvPr/>
        </p:nvCxnSpPr>
        <p:spPr>
          <a:xfrm>
            <a:off x="9514871" y="679462"/>
            <a:ext cx="462784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FB8211FD-6D87-497D-9807-A5793F29CDAA}"/>
              </a:ext>
            </a:extLst>
          </p:cNvPr>
          <p:cNvSpPr txBox="1"/>
          <p:nvPr/>
        </p:nvSpPr>
        <p:spPr>
          <a:xfrm>
            <a:off x="8062254" y="299055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12">
            <a:extLst>
              <a:ext uri="{FF2B5EF4-FFF2-40B4-BE49-F238E27FC236}">
                <a16:creationId xmlns:a16="http://schemas.microsoft.com/office/drawing/2014/main" id="{8F21D639-63D4-4965-838E-5BBD46FC3DE7}"/>
              </a:ext>
            </a:extLst>
          </p:cNvPr>
          <p:cNvSpPr txBox="1"/>
          <p:nvPr/>
        </p:nvSpPr>
        <p:spPr>
          <a:xfrm>
            <a:off x="-9610" y="-28659"/>
            <a:ext cx="2161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Supplemental Fig. S1 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85483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4</TotalTime>
  <Words>199</Words>
  <Application>Microsoft Office PowerPoint</Application>
  <PresentationFormat>宽屏</PresentationFormat>
  <Paragraphs>2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tengda</dc:creator>
  <cp:lastModifiedBy>DL</cp:lastModifiedBy>
  <cp:revision>51</cp:revision>
  <dcterms:created xsi:type="dcterms:W3CDTF">2022-06-16T08:55:52Z</dcterms:created>
  <dcterms:modified xsi:type="dcterms:W3CDTF">2022-06-18T08:00:18Z</dcterms:modified>
</cp:coreProperties>
</file>